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5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27302C-865A-B3AC-7272-9EBDBD8B8E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F66409C-41EB-A8BC-49F3-742FAD8F00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9973AB-9762-0E5F-03AD-D6F69117C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61002-625B-4289-8035-1D62B01218CF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0E14D2-02A1-DC94-6498-1740B7A03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B8557A-FB35-0999-DBB0-B367182EE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E7869-A2D1-4B88-A5DD-FFE744AEB2D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68689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BAFB9B-E0BE-9CC7-2FFE-075CFEA0DA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FAE1B7-BF92-61B9-40D1-ABC620EC44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A0CEF9-7C92-E182-E5D6-ABD59EA2F0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61002-625B-4289-8035-1D62B01218CF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1A4D91-B084-B2E2-0635-103AFB6F8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53CE4B-EB0B-AA46-7F0C-8D6335BEFE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E7869-A2D1-4B88-A5DD-FFE744AEB2D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22754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B3AF442-66FB-BD3B-B2A4-2518ABF7B8D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10A000-78D5-8E4F-717A-091D2FE108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8E70DC-F652-4C0E-B3DF-4922537B5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61002-625B-4289-8035-1D62B01218CF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6566E8-3FB2-F993-61E8-A143465258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7F1318-75CC-D50E-C642-1220595B7A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E7869-A2D1-4B88-A5DD-FFE744AEB2D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53135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21BA7F-B25C-CFE2-A20C-8AB3A15887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526FF0-B955-62DB-FF28-29149E63B5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DBD26F-A2C8-59B8-B328-A177E503CD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61002-625B-4289-8035-1D62B01218CF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A87E16-95C2-80FC-2E31-75E9DEB183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9E014E-73DC-239F-ED3E-396A33299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E7869-A2D1-4B88-A5DD-FFE744AEB2D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59596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08793B-E301-9F3B-F635-FFBC4AC5CB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868417-45CD-D9B1-AA26-3EBAEF0470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7C3DDA-8C0E-2A70-42A8-FE2720325F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61002-625B-4289-8035-1D62B01218CF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3E699C-8E3C-9F3A-0A0F-32ED39CC2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C33099-9D50-A297-7FD5-2DEDD58DCB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E7869-A2D1-4B88-A5DD-FFE744AEB2D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17017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EFF7B2-7963-EF53-83FB-DE1CF5884A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1B7D66-CFF5-01E7-C6D4-ABC5F0076C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B51F8D-5B03-ED64-3FCA-CDE6EE0FE1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44DDBF-EABE-D770-031E-43E3FBEC0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61002-625B-4289-8035-1D62B01218CF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6556E0-699F-BD97-5577-8203C56B7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1DFB8C-A18B-CFAA-B5C1-65659EBCE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E7869-A2D1-4B88-A5DD-FFE744AEB2D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039699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F103E0-8E42-0D56-0EA3-E6A3F15347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F4BBD5-815A-7898-2DF7-93F7CCED80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F10449-7967-9B1E-BACA-B6697774C8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13E6D5-15A2-AEBA-0F2E-1354595A61B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68C722A-048D-1C27-7AE5-45206093AF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DAF67DC-D7FC-C0B5-2D94-86CB32E77C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61002-625B-4289-8035-1D62B01218CF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CCF660-0A0A-F4DD-226A-A3964CE3B6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9F21947-C3C1-CBA3-3E8F-4993A69DD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E7869-A2D1-4B88-A5DD-FFE744AEB2D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40225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77A9A9-FB57-F1D9-8CA7-8420F4C4AE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6751D7B-508A-F4FE-3247-E4C88079F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61002-625B-4289-8035-1D62B01218CF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299E230-5A47-5A4C-AAAF-7A09B536DA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613C23E-7982-6E81-20FD-F29AB7BF4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E7869-A2D1-4B88-A5DD-FFE744AEB2D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69017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642DB34-8D50-3447-F8B4-47F29B67F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61002-625B-4289-8035-1D62B01218CF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B7FB614-74D8-BBF5-1A23-C56492BB9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223734-7B49-F902-5A80-7CDF2F7C18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E7869-A2D1-4B88-A5DD-FFE744AEB2D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55328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02194A-1F0B-8301-F5F1-76FD58FF51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34875-6442-B07F-2A5E-9CBFDB31FC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04048E-88C7-B64D-9A19-E27B8D248A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D67BA7-F2E2-5D44-7D22-F643207DC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61002-625B-4289-8035-1D62B01218CF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B984E8-3494-6DFB-FE21-1042678B90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7390C9-14B6-4420-2F9E-E970F4F1F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E7869-A2D1-4B88-A5DD-FFE744AEB2D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75078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AFB1F9-A4E5-1FAF-CA1D-7A1B10355A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556E950-193E-2871-5927-7EFBE30FB6E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973DFF-11F0-FEA6-51CD-3229D80D5E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B607A1-6486-C4AC-2748-AA75578A9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761002-625B-4289-8035-1D62B01218CF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8BC2DC-81AC-59BF-5930-CC5ABC9A5C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2E3B9D-20AC-0A52-5B66-7DFFCF875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E7869-A2D1-4B88-A5DD-FFE744AEB2D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65800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562BD1F-A169-1CB7-2C85-8FFD7C1658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53B1A8-5850-8192-6B96-0EA96DDCB3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B1F067-F2C3-92DA-9551-26D9868A3C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6761002-625B-4289-8035-1D62B01218CF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D04090-FB2B-FD18-5366-3DDFE9E045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E16E78-9A68-4EE5-A9EF-2414FE2032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A1E7869-A2D1-4B88-A5DD-FFE744AEB2D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98010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B0A8A95-A823-8166-CE8A-2EBDF1065F80}"/>
              </a:ext>
            </a:extLst>
          </p:cNvPr>
          <p:cNvGraphicFramePr>
            <a:graphicFrameLocks noGrp="1"/>
          </p:cNvGraphicFramePr>
          <p:nvPr/>
        </p:nvGraphicFramePr>
        <p:xfrm>
          <a:off x="715617" y="1266144"/>
          <a:ext cx="8393214" cy="3637788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2684075">
                  <a:extLst>
                    <a:ext uri="{9D8B030D-6E8A-4147-A177-3AD203B41FA5}">
                      <a16:colId xmlns:a16="http://schemas.microsoft.com/office/drawing/2014/main" val="2157845387"/>
                    </a:ext>
                  </a:extLst>
                </a:gridCol>
                <a:gridCol w="2836985">
                  <a:extLst>
                    <a:ext uri="{9D8B030D-6E8A-4147-A177-3AD203B41FA5}">
                      <a16:colId xmlns:a16="http://schemas.microsoft.com/office/drawing/2014/main" val="1698579339"/>
                    </a:ext>
                  </a:extLst>
                </a:gridCol>
                <a:gridCol w="2872154">
                  <a:extLst>
                    <a:ext uri="{9D8B030D-6E8A-4147-A177-3AD203B41FA5}">
                      <a16:colId xmlns:a16="http://schemas.microsoft.com/office/drawing/2014/main" val="2818783533"/>
                    </a:ext>
                  </a:extLst>
                </a:gridCol>
              </a:tblGrid>
              <a:tr h="164227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solidFill>
                            <a:schemeClr val="tx1"/>
                          </a:solidFill>
                          <a:effectLst/>
                        </a:rPr>
                        <a:t>Variable</a:t>
                      </a:r>
                      <a:endParaRPr lang="nl-NL" sz="200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solidFill>
                            <a:schemeClr val="tx1"/>
                          </a:solidFill>
                          <a:effectLst/>
                        </a:rPr>
                        <a:t>CNI (18)</a:t>
                      </a:r>
                      <a:endParaRPr lang="nl-NL" sz="200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dirty="0">
                          <a:solidFill>
                            <a:schemeClr val="tx1"/>
                          </a:solidFill>
                          <a:effectLst/>
                        </a:rPr>
                        <a:t>Belatacept (21)</a:t>
                      </a:r>
                      <a:endParaRPr lang="nl-NL" sz="200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9197894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Age (mean, SEM)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59 (2,6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58 (3,6</a:t>
                      </a: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6263981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Female sex (n,%)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6 (33%) 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9 (43%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6824073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LDL (mean, mmol/L, SEM)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 2,8 (0,3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3,0 (0,2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6746927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Months since transplantation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31 (5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35 (3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6059967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Dialysis vintage in months 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19 (6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18 (6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0355211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History of smoking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11 (61%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 10 (48%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4517040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Diabetes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3 (17%) 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8 (38%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3027882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Systolic BP (mmHg)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142 (5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133 (4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7053797"/>
                  </a:ext>
                </a:extLst>
              </a:tr>
              <a:tr h="164227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Diastolic BP (mmHg)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84 (2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78 (2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039690"/>
                  </a:ext>
                </a:extLst>
              </a:tr>
              <a:tr h="8365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eGFR (ml/min/1.73m2)</a:t>
                      </a:r>
                      <a:endParaRPr lang="nl-NL" sz="1600" b="0" dirty="0">
                        <a:solidFill>
                          <a:schemeClr val="tx1"/>
                        </a:solidFill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56 (4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2000" b="0" dirty="0">
                          <a:effectLst/>
                        </a:rPr>
                        <a:t>47 (3)</a:t>
                      </a:r>
                      <a:endParaRPr lang="nl-NL" sz="2000" b="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29268" marR="29268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1143702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0C2361B-4AE3-BD61-9211-BEA4CC953DAB}"/>
              </a:ext>
            </a:extLst>
          </p:cNvPr>
          <p:cNvSpPr txBox="1"/>
          <p:nvPr/>
        </p:nvSpPr>
        <p:spPr>
          <a:xfrm>
            <a:off x="715617" y="5287617"/>
            <a:ext cx="669785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table 2:</a:t>
            </a:r>
          </a:p>
          <a:p>
            <a:r>
              <a:rPr lang="en-US" dirty="0"/>
              <a:t>Baseline characteristics of patients participating in cell-painting essay.</a:t>
            </a:r>
          </a:p>
          <a:p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0768958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3</Words>
  <Application>Microsoft Office PowerPoint</Application>
  <PresentationFormat>Widescreen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mbri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redewold, O.W. (INT)</dc:creator>
  <cp:lastModifiedBy>Bredewold, Edwin (INT - LUMC)</cp:lastModifiedBy>
  <cp:revision>1</cp:revision>
  <dcterms:created xsi:type="dcterms:W3CDTF">2025-12-01T11:27:16Z</dcterms:created>
  <dcterms:modified xsi:type="dcterms:W3CDTF">2026-04-03T08:24:15Z</dcterms:modified>
</cp:coreProperties>
</file>